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36" userDrawn="1">
          <p15:clr>
            <a:srgbClr val="A4A3A4"/>
          </p15:clr>
        </p15:guide>
        <p15:guide id="3" pos="720" userDrawn="1">
          <p15:clr>
            <a:srgbClr val="A4A3A4"/>
          </p15:clr>
        </p15:guide>
        <p15:guide id="4" pos="3600" userDrawn="1">
          <p15:clr>
            <a:srgbClr val="A4A3A4"/>
          </p15:clr>
        </p15:guide>
        <p15:guide id="5" pos="3504" userDrawn="1">
          <p15:clr>
            <a:srgbClr val="A4A3A4"/>
          </p15:clr>
        </p15:guide>
        <p15:guide id="6" pos="10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  <a:srgbClr val="B80000"/>
    <a:srgbClr val="990000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236" y="108"/>
      </p:cViewPr>
      <p:guideLst>
        <p:guide orient="horz" pos="2880"/>
        <p:guide pos="2136"/>
        <p:guide pos="720"/>
        <p:guide pos="3600"/>
        <p:guide pos="3504"/>
        <p:guide pos="10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7808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1067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3727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834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7922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4091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03621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6065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1863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8316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7947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3EBC8-4DA8-46FC-AC2E-850628D305C1}" type="datetimeFigureOut">
              <a:rPr lang="en-IN" smtClean="0"/>
              <a:t>21-11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96590-3CB9-49DE-BA06-9729B1B90A7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61001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55798" y="231684"/>
            <a:ext cx="2973202" cy="2255959"/>
            <a:chOff x="170688" y="753693"/>
            <a:chExt cx="2973202" cy="2255959"/>
          </a:xfrm>
        </p:grpSpPr>
        <p:pic>
          <p:nvPicPr>
            <p:cNvPr id="19" name="Picture 18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70688" y="753693"/>
              <a:ext cx="2923032" cy="21922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" name="TextBox 18"/>
            <p:cNvSpPr txBox="1"/>
            <p:nvPr/>
          </p:nvSpPr>
          <p:spPr>
            <a:xfrm>
              <a:off x="2843808" y="2640320"/>
              <a:ext cx="300082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I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488417" y="232183"/>
            <a:ext cx="2958818" cy="2237671"/>
            <a:chOff x="3117342" y="753693"/>
            <a:chExt cx="2958818" cy="2237671"/>
          </a:xfrm>
        </p:grpSpPr>
        <p:pic>
          <p:nvPicPr>
            <p:cNvPr id="17" name="Picture 16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117342" y="753693"/>
              <a:ext cx="2923032" cy="21922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8" name="TextBox 16"/>
            <p:cNvSpPr txBox="1"/>
            <p:nvPr/>
          </p:nvSpPr>
          <p:spPr>
            <a:xfrm>
              <a:off x="5763254" y="2622032"/>
              <a:ext cx="312906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I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442552" y="2554196"/>
            <a:ext cx="2952920" cy="2241832"/>
            <a:chOff x="6053390" y="753693"/>
            <a:chExt cx="2952920" cy="2241832"/>
          </a:xfrm>
        </p:grpSpPr>
        <p:pic>
          <p:nvPicPr>
            <p:cNvPr id="15" name="Picture 14"/>
            <p:cNvPicPr>
              <a:picLocks noChangeAspect="1" noChangeArrowheads="1"/>
            </p:cNvPicPr>
            <p:nvPr/>
          </p:nvPicPr>
          <p:blipFill>
            <a:blip r:embed="rId4" cstate="print"/>
            <a:srcRect l="15875" r="7925"/>
            <a:stretch>
              <a:fillRect/>
            </a:stretch>
          </p:blipFill>
          <p:spPr bwMode="auto">
            <a:xfrm>
              <a:off x="6053390" y="753693"/>
              <a:ext cx="2924494" cy="21922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6" name="TextBox 14"/>
            <p:cNvSpPr txBox="1"/>
            <p:nvPr/>
          </p:nvSpPr>
          <p:spPr>
            <a:xfrm>
              <a:off x="8719052" y="2626193"/>
              <a:ext cx="287258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I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3488417" y="2557061"/>
            <a:ext cx="2923200" cy="2240136"/>
            <a:chOff x="1639822" y="2964792"/>
            <a:chExt cx="2923200" cy="2240136"/>
          </a:xfrm>
        </p:grpSpPr>
        <p:pic>
          <p:nvPicPr>
            <p:cNvPr id="13" name="Picture 12"/>
            <p:cNvPicPr>
              <a:picLocks noChangeAspect="1" noChangeArrowheads="1"/>
            </p:cNvPicPr>
            <p:nvPr/>
          </p:nvPicPr>
          <p:blipFill rotWithShape="1">
            <a:blip r:embed="rId5" cstate="print"/>
            <a:srcRect l="31734" t="16315" r="14318" b="20935"/>
            <a:stretch/>
          </p:blipFill>
          <p:spPr bwMode="auto">
            <a:xfrm>
              <a:off x="1639822" y="2964792"/>
              <a:ext cx="2923200" cy="219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4" name="TextBox 9"/>
            <p:cNvSpPr txBox="1"/>
            <p:nvPr/>
          </p:nvSpPr>
          <p:spPr>
            <a:xfrm>
              <a:off x="4240044" y="4835596"/>
              <a:ext cx="312906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d</a:t>
              </a:r>
              <a:endParaRPr lang="en-I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933872" y="4885815"/>
            <a:ext cx="2923200" cy="2249428"/>
            <a:chOff x="4577334" y="2964792"/>
            <a:chExt cx="2923200" cy="2249428"/>
          </a:xfrm>
        </p:grpSpPr>
        <p:pic>
          <p:nvPicPr>
            <p:cNvPr id="11" name="Picture 10"/>
            <p:cNvPicPr>
              <a:picLocks noChangeAspect="1" noChangeArrowheads="1"/>
            </p:cNvPicPr>
            <p:nvPr/>
          </p:nvPicPr>
          <p:blipFill rotWithShape="1">
            <a:blip r:embed="rId6" cstate="print"/>
            <a:srcRect l="8725" r="8725"/>
            <a:stretch/>
          </p:blipFill>
          <p:spPr bwMode="auto">
            <a:xfrm>
              <a:off x="4577334" y="2964792"/>
              <a:ext cx="2923200" cy="219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" name="TextBox 7"/>
            <p:cNvSpPr txBox="1"/>
            <p:nvPr/>
          </p:nvSpPr>
          <p:spPr>
            <a:xfrm>
              <a:off x="7192863" y="4844888"/>
              <a:ext cx="287258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e</a:t>
              </a:r>
              <a:endParaRPr lang="en-I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0" name="Rectangle 9"/>
          <p:cNvSpPr/>
          <p:nvPr/>
        </p:nvSpPr>
        <p:spPr>
          <a:xfrm>
            <a:off x="-1019175" y="2317315"/>
            <a:ext cx="8896350" cy="4495800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IN"/>
          </a:p>
        </p:txBody>
      </p:sp>
      <p:sp>
        <p:nvSpPr>
          <p:cNvPr id="3" name="Rectangle 2"/>
          <p:cNvSpPr/>
          <p:nvPr/>
        </p:nvSpPr>
        <p:spPr>
          <a:xfrm>
            <a:off x="455798" y="7147435"/>
            <a:ext cx="5945747" cy="8356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GB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2 Fig. 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Root morphology under salt stress. </a:t>
            </a:r>
            <a:r>
              <a:rPr lang="en-IN" sz="14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Changes </a:t>
            </a:r>
            <a:r>
              <a:rPr lang="en-IN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in root morphology of cumin seedling treated with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(a) 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m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, (b) 3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m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, (c) 5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m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, (d) 8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m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 and (e) 10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m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 of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NaCl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 concentration</a:t>
            </a:r>
            <a:r>
              <a:rPr lang="en-US" sz="14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4730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6</TotalTime>
  <Words>56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ang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inash Mishra</dc:creator>
  <cp:lastModifiedBy>Avinash Mishra</cp:lastModifiedBy>
  <cp:revision>34</cp:revision>
  <dcterms:created xsi:type="dcterms:W3CDTF">2015-01-03T04:36:46Z</dcterms:created>
  <dcterms:modified xsi:type="dcterms:W3CDTF">2015-11-21T07:01:00Z</dcterms:modified>
</cp:coreProperties>
</file>